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  <p:sldId id="258" r:id="rId3"/>
  </p:sldIdLst>
  <p:sldSz cx="9144000" cy="5143500" type="screen16x9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ptos" panose="020B0004020202020204" pitchFamily="34" charset="0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0D84A80-CE1A-4ADD-A5D6-71699BD26863}">
          <p14:sldIdLst/>
        </p14:section>
        <p14:section name="Untitled Section" id="{A2CCFE4C-EF63-491B-AD2E-AD524F6B4059}">
          <p14:sldIdLst>
            <p14:sldId id="270"/>
            <p14:sldId id="258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906" y="7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453B-90C4-A5EB-0B81-753C10CA0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F955DC-C7C1-4376-9534-E92E57EBDDD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57893A-0A44-7816-5EAD-6D33A8B5D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88B4FE-6063-6855-9B98-8AAA0258A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B93433F-34DA-4C69-92AD-F7FC1E3C2F96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839957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3351E-E0D2-01B5-78B6-5B60527CE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9BAF80-B914-4C1A-BE4E-3B42C85AEC7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D426FF-254F-7656-FD21-6950B40D89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BA51D4-C21A-D49D-7997-AE8E4EB0D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CA40401-FB40-434F-806C-46E51DAE8CF1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04721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EEC6A0-5E7A-346F-EDD6-92C02A651F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18C23E-DF59-48E9-BEE9-32AC4128E6B7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E6EB7D-C592-A7B5-7DC4-0D51D5DE7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4F9589-8F4B-880D-1DAA-D8EDC9056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F9A0D-A95F-4A2B-89C4-0C13CF3957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169432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211EDE-7073-2202-9155-2CDB569A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496D4-D55C-4279-9A96-FF9BBB5260DE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4D387E-6EAE-95EC-9B0D-D48EA68D5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DB3C6F-B9E3-D9B9-6F11-823047922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CDDE7DE-AD13-4FAA-8224-CED41ED18AA8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247312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51D4B2-51D9-F669-DC71-933217BD2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688E2F-CA85-4EBF-A7CE-ED2F0151CFE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302B2-921D-5B8C-02DF-2393AA7AF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5B5777-2A9A-3D46-7C1F-51CA849BE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6154E6B-3393-42B2-A519-A5E57359B0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431839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1D1BB1AF-A5F6-AB98-9FE0-5D8056ABBB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57D44B-DCFE-4542-8037-E2F89F857E4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D63195A3-6C94-BECF-ADFA-F600E7BD4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9E096395-C0FE-B7CC-C5B7-3E39643358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0CD20EF-1CA4-45F0-B212-CF6C7EBC03A7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14653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7884EBDA-9F96-65CB-8C91-EAB789826E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8F33588-C768-42F3-B320-CA9D66169FC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C6673F07-4BF2-539B-F064-3C01C814B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2595270C-309B-6A76-E0A2-69D7B6144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EBC293B-7CA6-487F-B4A5-E2E65FFBB48E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37475109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5388E6E5-2972-90D8-0D59-B553E3A16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5B427F-F011-4806-ABDD-BCB025D97FB6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1FD084FB-A36D-4FBB-3AE0-C91CA0E850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566E01CD-3B7F-AF05-4489-98E6F9DDA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BE2C52B1-5DEE-4F53-B88B-35B8519700E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685632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D808274A-3A5D-4BDA-9028-1CEC991E8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E14E764-C10B-4DAC-98D8-A573F5949B81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C0D4B752-7E7C-033E-E1AB-DF2A5B036F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BFB4D461-81FB-2237-CB38-7FAED3E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507B75A-CC9D-4F89-BC20-8F2CF2E7E54D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334322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4946A807-79E0-C924-F632-B0FC9DDB4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57B315-1BC6-494C-BFE9-0E64193A442B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3E3BFBEA-C487-3C5D-4A81-0FD60691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D071BBDF-D2BE-E117-614B-35A7CEB08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39EC089-A1E2-4348-A6F0-62BCC7C13DAB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11136413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92AB9644-9619-DE4D-A625-5F1CA37E3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72EA2-86FE-4500-9270-7D9CAFD90180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6AD111D1-10A9-EB92-9A2D-994E148CF4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C20702F5-837A-94B3-70F1-3B0DBA656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934D1-4156-4698-81F1-1C3A6887CEC5}" type="slidenum">
              <a:rPr lang="ar-YE" altLang="ar-YE"/>
              <a:pPr/>
              <a:t>‹#›</a:t>
            </a:fld>
            <a:endParaRPr lang="ar-YE" altLang="ar-YE"/>
          </a:p>
        </p:txBody>
      </p:sp>
    </p:spTree>
    <p:extLst>
      <p:ext uri="{BB962C8B-B14F-4D97-AF65-F5344CB8AC3E}">
        <p14:creationId xmlns:p14="http://schemas.microsoft.com/office/powerpoint/2010/main" val="272893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891C6471-FC74-6D79-2C87-52AC88FDD7EE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274638"/>
            <a:ext cx="7886700" cy="993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itle style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D8CC31AA-3859-B8A0-D401-40D861F2336B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628650" y="1370013"/>
            <a:ext cx="7886700" cy="3262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ar-YE"/>
              <a:t>Click to edit Master text styles</a:t>
            </a:r>
          </a:p>
          <a:p>
            <a:pPr lvl="1"/>
            <a:r>
              <a:rPr lang="en-US" altLang="ar-YE"/>
              <a:t>Second level</a:t>
            </a:r>
          </a:p>
          <a:p>
            <a:pPr lvl="2"/>
            <a:r>
              <a:rPr lang="en-US" altLang="ar-YE"/>
              <a:t>Third level</a:t>
            </a:r>
          </a:p>
          <a:p>
            <a:pPr lvl="3"/>
            <a:r>
              <a:rPr lang="en-US" altLang="ar-YE"/>
              <a:t>Fourth level</a:t>
            </a:r>
          </a:p>
          <a:p>
            <a:pPr lvl="4"/>
            <a:r>
              <a:rPr lang="en-US" altLang="ar-YE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B8E075-2ED6-59B5-B9E8-D858F6E7C3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82514F9A-75F6-4D34-B512-92A57F93648C}" type="datetimeFigureOut">
              <a:rPr lang="ar-YE"/>
              <a:pPr>
                <a:defRPr/>
              </a:pPr>
              <a:t>21/11/1447</a:t>
            </a:fld>
            <a:endParaRPr lang="ar-Y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454FD9-1F2E-5D95-FFFC-341D9B97B65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82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ar-Y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E5039F-C134-F82E-C2F4-3E2B8CF6B5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4637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767676"/>
                </a:solidFill>
              </a:defRPr>
            </a:lvl1pPr>
          </a:lstStyle>
          <a:p>
            <a:fld id="{B232C4A3-EF3D-4E57-A5A9-C8A551E1D9FA}" type="slidenum">
              <a:rPr lang="ar-YE" altLang="ar-YE"/>
              <a:pPr/>
              <a:t>‹#›</a:t>
            </a:fld>
            <a:endParaRPr lang="ar-YE" altLang="ar-Y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2pPr>
      <a:lvl3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3pPr>
      <a:lvl4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4pPr>
      <a:lvl5pPr algn="l" defTabSz="685800" rtl="1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5pPr>
      <a:lvl6pPr marL="4572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6pPr>
      <a:lvl7pPr marL="9144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7pPr>
      <a:lvl8pPr marL="13716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8pPr>
      <a:lvl9pPr marL="1828800" algn="l" defTabSz="685800" rtl="1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Aptos Display" pitchFamily="34" charset="0"/>
        </a:defRPr>
      </a:lvl9pPr>
    </p:titleStyle>
    <p:bodyStyle>
      <a:lvl1pPr marL="171450" indent="-171450" algn="r" defTabSz="685800" rtl="1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76D8BC-02CD-27C7-B765-A563DCCFC6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 algn="l" rtl="0">
              <a:buNone/>
            </a:pPr>
            <a:r>
              <a:rPr lang="en-US" sz="1600" b="1" dirty="0">
                <a:cs typeface="+mj-cs"/>
              </a:rPr>
              <a:t>Figure S2.4.</a:t>
            </a:r>
            <a:r>
              <a:rPr lang="en-US" sz="1600" dirty="0">
                <a:cs typeface="+mj-cs"/>
              </a:rPr>
              <a:t> </a:t>
            </a:r>
            <a:r>
              <a:rPr lang="en-US" sz="1600" i="1" dirty="0">
                <a:cs typeface="+mj-cs"/>
              </a:rPr>
              <a:t>Second-order structural equation model examining the association between the higher-order JCI patient-centered standards construct and self-reported nursing performance. </a:t>
            </a:r>
            <a:r>
              <a:rPr lang="en-US" sz="1600" i="1" dirty="0" err="1">
                <a:cs typeface="+mj-cs"/>
              </a:rPr>
              <a:t>Standardised</a:t>
            </a:r>
            <a:r>
              <a:rPr lang="en-US" sz="1600" i="1" dirty="0">
                <a:cs typeface="+mj-cs"/>
              </a:rPr>
              <a:t> path coefficients are displayed. The model explains 78.4% of the variance in self-reported nursing performance (R² = 0.784). Path from JCI standards to nursing performance: β = 0.885, p &lt; 0.001. Model fit: χ²/</a:t>
            </a:r>
            <a:r>
              <a:rPr lang="en-US" sz="1600" i="1" dirty="0" err="1">
                <a:cs typeface="+mj-cs"/>
              </a:rPr>
              <a:t>df</a:t>
            </a:r>
            <a:r>
              <a:rPr lang="en-US" sz="1600" i="1" dirty="0">
                <a:cs typeface="+mj-cs"/>
              </a:rPr>
              <a:t> = 2.534; CFI = 0.851; RMSEA = 0.054. CFI, comparative fit index; JCI, Joint Commission International; RMSEA, root mean square error of approximation.</a:t>
            </a:r>
            <a:endParaRPr lang="en-US" sz="1600" dirty="0">
              <a:cs typeface="+mj-cs"/>
            </a:endParaRPr>
          </a:p>
          <a:p>
            <a:pPr algn="l" rtl="0"/>
            <a:endParaRPr lang="ar-YE" dirty="0"/>
          </a:p>
        </p:txBody>
      </p:sp>
    </p:spTree>
    <p:extLst>
      <p:ext uri="{BB962C8B-B14F-4D97-AF65-F5344CB8AC3E}">
        <p14:creationId xmlns:p14="http://schemas.microsoft.com/office/powerpoint/2010/main" val="10629167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>
            <a:extLst>
              <a:ext uri="{FF2B5EF4-FFF2-40B4-BE49-F238E27FC236}">
                <a16:creationId xmlns:a16="http://schemas.microsoft.com/office/drawing/2014/main" id="{B6EEC7E0-B50C-7FF3-E91E-861B03DE8E2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/>
        </p:blipFill>
        <p:spPr bwMode="auto">
          <a:xfrm>
            <a:off x="363557" y="133579"/>
            <a:ext cx="8251634" cy="50099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</TotalTime>
  <Words>99</Words>
  <Application>Microsoft Office PowerPoint</Application>
  <PresentationFormat>On-screen Show (16:9)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عرض تقديمي في PowerPoint</dc:title>
  <dc:creator>Haitham Jowah</dc:creator>
  <cp:lastModifiedBy>Haitham Jowah</cp:lastModifiedBy>
  <cp:revision>8</cp:revision>
  <dcterms:created xsi:type="dcterms:W3CDTF">2026-05-06T20:22:58Z</dcterms:created>
  <dcterms:modified xsi:type="dcterms:W3CDTF">2026-05-07T01:43:00Z</dcterms:modified>
</cp:coreProperties>
</file>